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6" r:id="rId3"/>
    <p:sldId id="257" r:id="rId4"/>
    <p:sldId id="258" r:id="rId5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5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1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69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946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241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6643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468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005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37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0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249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503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81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03BC5-3B9D-4A43-A998-6968159B76C8}" type="datetimeFigureOut">
              <a:rPr kumimoji="1" lang="ja-JP" altLang="en-US" smtClean="0"/>
              <a:t>2021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864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863588D6-E587-4959-A0C3-8E33AE649D7E}"/>
              </a:ext>
            </a:extLst>
          </p:cNvPr>
          <p:cNvSpPr/>
          <p:nvPr/>
        </p:nvSpPr>
        <p:spPr>
          <a:xfrm>
            <a:off x="226584" y="6932222"/>
            <a:ext cx="623733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1.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 sequence and primer sets for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vitro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ranscription of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S5-1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ouble-stranded RNA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04681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6702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863588D6-E587-4959-A0C3-8E33AE649D7E}"/>
              </a:ext>
            </a:extLst>
          </p:cNvPr>
          <p:cNvSpPr/>
          <p:nvPr/>
        </p:nvSpPr>
        <p:spPr>
          <a:xfrm>
            <a:off x="226584" y="6932222"/>
            <a:ext cx="623733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ure 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2. 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xpression profiles of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b="1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itin synthase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, including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A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B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C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D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E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F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4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G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H), and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I) on soybean leaves.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oybean plants were spray-inoculated with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1 x 10</a:t>
            </a:r>
            <a:r>
              <a:rPr lang="en-US" altLang="ja-JP" sz="1200" baseline="30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pores/ml). Total RNAs including soybean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were purified at 0, 2, 4, 6, 12, and 24 hours after inoculation, and expression profiles were evaluated using RT-qPCR.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longation factor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EF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ubiquitin 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UBQ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ere used to normalize the samples. Vertical bars indicate the standard error of the means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4). Asterisks indicate a significant difference between 0 h and each time point in a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est (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, *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1).</a:t>
            </a:r>
            <a:endParaRPr lang="ja-JP" altLang="ja-JP" sz="12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18714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312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863588D6-E587-4959-A0C3-8E33AE649D7E}"/>
              </a:ext>
            </a:extLst>
          </p:cNvPr>
          <p:cNvSpPr/>
          <p:nvPr/>
        </p:nvSpPr>
        <p:spPr>
          <a:xfrm>
            <a:off x="226584" y="6932222"/>
            <a:ext cx="6237331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ure 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3. 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xpression profiles of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b="1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itin synthase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, including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A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B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C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D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E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F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4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G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H), and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I) on polyethylene tapes treated with double-stranded RNA.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Down-regulation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of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s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ranscripts were quantified on polyethylene tapes treated with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GF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dsRNA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dsRNA. Polyethylene tapes were spray-inoculated with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1 x 10</a:t>
            </a:r>
            <a:r>
              <a:rPr lang="en-US" altLang="ja-JP" sz="1200" baseline="30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pores/ml). Total RNAs of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were purified 6 hours after inoculation, and expression profiles were evaluated using RT-qPCR.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longation factor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EF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ubiquitin 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UBQ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ere used to normalize the samples. Vertical bars indicate the standard error of the means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4). Asterisks indicate a significant difference between 0 time and each time point in a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est (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, *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1).</a:t>
            </a:r>
            <a:endParaRPr lang="ja-JP" altLang="ja-JP" sz="12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3326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8984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863588D6-E587-4959-A0C3-8E33AE649D7E}"/>
              </a:ext>
            </a:extLst>
          </p:cNvPr>
          <p:cNvSpPr/>
          <p:nvPr/>
        </p:nvSpPr>
        <p:spPr>
          <a:xfrm>
            <a:off x="310334" y="6314812"/>
            <a:ext cx="6237331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4.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 expression profiles of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ybean defense marker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defense-related genes in response to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b="1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oculation on CNF-treated leaves.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 expression profiles of soybean defense marker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defense-related genes including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thogenesis-related protein 1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1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2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4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0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10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enylalanine ammonia-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y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L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innamat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4-hydroxyl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4H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-coumarate CoA lig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CL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ffeoyl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oenzyme A O-methyltransferase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CoAOMT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lc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ynth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S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lc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duct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lc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omer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oflav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ynth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FS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and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oflav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ductase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F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in response to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oculation on CNF-treated leaves. Soybean plants were spray-inoculated with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1 x 10</a:t>
            </a:r>
            <a:r>
              <a:rPr lang="en-US" altLang="ja-JP" sz="1200" kern="100" baseline="30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pores/ml). Total RNAs including soybean and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re purified at 6, 12, and 24 hours after inoculation, and expression profiles were evaluated using RT-qPCR. Soybean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longation facto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i="1" kern="100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mEF1</a:t>
            </a:r>
            <a:r>
              <a:rPr lang="en-US" altLang="ja-JP" sz="1200" i="1" kern="100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nd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biquitin 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mUBQ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used to normalize the samples. Significant differences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) are indicated by different letters based on a Tukey’s honestly significant difference (HSD) test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06097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127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595</Words>
  <Application>Microsoft Office PowerPoint</Application>
  <PresentationFormat>画面に合わせる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ＭＳ Ｐゴシック</vt:lpstr>
      <vt:lpstr>ＭＳ 明朝</vt:lpstr>
      <vt:lpstr>Arial</vt:lpstr>
      <vt:lpstr>Calibri</vt:lpstr>
      <vt:lpstr>Calibri Light</vt:lpstr>
      <vt:lpstr>Century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筑波大学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賀康博</dc:creator>
  <cp:lastModifiedBy>石賀康博</cp:lastModifiedBy>
  <cp:revision>5</cp:revision>
  <dcterms:created xsi:type="dcterms:W3CDTF">2021-06-14T00:01:50Z</dcterms:created>
  <dcterms:modified xsi:type="dcterms:W3CDTF">2021-06-15T00:38:14Z</dcterms:modified>
</cp:coreProperties>
</file>